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119" d="100"/>
          <a:sy n="119" d="100"/>
        </p:scale>
        <p:origin x="96" y="3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3F1F1E-F503-443D-980A-DF6BCDC3A6E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A47935D-133C-4B2F-BD24-2ACE38471FA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73AFC6E-95A8-4919-83D6-BA3041E617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33761-7749-4B39-AA4E-F2614C788D62}" type="datetimeFigureOut">
              <a:rPr lang="en-US" smtClean="0"/>
              <a:t>8/1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E9D43C-978E-4699-A3B6-DCC8839E9B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941DA5-3A52-478F-827B-9ED730B1F0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FE5BA-FAA6-4651-81EC-DEAC246416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4055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F24519-963F-4530-8667-D9CA6CF99D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0FB54A9-199E-4574-804C-0A9AA6C25F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1F27BC-1205-4B6B-83E6-D831667F86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33761-7749-4B39-AA4E-F2614C788D62}" type="datetimeFigureOut">
              <a:rPr lang="en-US" smtClean="0"/>
              <a:t>8/1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70249C-425C-425D-93B9-D1007A4B5B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0A7D71-00AC-4625-9114-1F2B5AFABB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FE5BA-FAA6-4651-81EC-DEAC246416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51886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A86FB26-F871-44A0-A91C-C3B854693B2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E274720-3937-402C-A522-D2A2D9E3532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62903E-8630-4E2A-A66E-791B813AA0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33761-7749-4B39-AA4E-F2614C788D62}" type="datetimeFigureOut">
              <a:rPr lang="en-US" smtClean="0"/>
              <a:t>8/1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73A25A-CD92-4826-A7DE-16AF5198B3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3B1B89-6676-4F3B-9A4F-17D8308351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FE5BA-FAA6-4651-81EC-DEAC246416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79373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443195-A8F8-419D-8720-F2C5C80D08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E27290E-5968-4EE7-9111-423AF6359F2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2444C4-D83A-47B3-8458-B9898F49B4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33761-7749-4B39-AA4E-F2614C788D62}" type="datetimeFigureOut">
              <a:rPr lang="en-US" smtClean="0"/>
              <a:t>8/1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C5E49E-D14E-498B-8758-7B08AE5464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553762-1B4F-4F88-AD6C-95CBAAEC84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FE5BA-FAA6-4651-81EC-DEAC246416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01576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DFD986-DF8D-4DEE-8BDE-132ABC1F50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72177E7-5FBB-4439-B801-36BC9D8E73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5004EC-F29D-43ED-B402-359718A19E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33761-7749-4B39-AA4E-F2614C788D62}" type="datetimeFigureOut">
              <a:rPr lang="en-US" smtClean="0"/>
              <a:t>8/1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ADAE18-3A85-4306-9B2D-EF0E3E6158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B11533-576B-4F8A-A96F-95753EC993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FE5BA-FAA6-4651-81EC-DEAC246416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02722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0116D7-C8F1-445E-80C3-5DE93C57F6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07F3016-53AB-44D5-BE65-1BF49BBD231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FBBCB52-744E-4ADF-9BB4-B5E2AA9971F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02C2DF4-A9E7-4DD5-890D-2CD620F0AF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33761-7749-4B39-AA4E-F2614C788D62}" type="datetimeFigureOut">
              <a:rPr lang="en-US" smtClean="0"/>
              <a:t>8/10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66F51C1-3EC1-47A6-9922-05D726361D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A4DE2C7-715D-4F8C-9368-5C1A1DEEF7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FE5BA-FAA6-4651-81EC-DEAC246416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14777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0E434A-9EAF-4E29-8944-8EA1562E70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4BC85F6-669E-459B-B0BB-15AA6751B2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31B953D-ECB5-4B85-8CC9-82BF4DB03F9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308F92A-3F9A-45FC-84F5-29A972A9D3B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22E4ED9-A82D-4A89-B3EA-D95BC3FF474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79071EA-4C8F-4CAC-B75E-269920F69B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33761-7749-4B39-AA4E-F2614C788D62}" type="datetimeFigureOut">
              <a:rPr lang="en-US" smtClean="0"/>
              <a:t>8/10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624BF2A-4EE7-469C-B165-CE7A15F907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AE09517-A06E-474B-BBAF-820A98E3C4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FE5BA-FAA6-4651-81EC-DEAC246416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78027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7E3DC3-4CD7-4281-95C3-088F6075FB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FEC7A01-7D69-43C4-ADC5-04F7543492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33761-7749-4B39-AA4E-F2614C788D62}" type="datetimeFigureOut">
              <a:rPr lang="en-US" smtClean="0"/>
              <a:t>8/10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A3A0F58-52B2-4FD2-94BB-94D3F2ADDD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A048248-891F-481D-AB90-3070C93556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FE5BA-FAA6-4651-81EC-DEAC246416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67775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4211FB7-1295-471E-BEB6-937FB90BFE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33761-7749-4B39-AA4E-F2614C788D62}" type="datetimeFigureOut">
              <a:rPr lang="en-US" smtClean="0"/>
              <a:t>8/10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D2B494B-20E9-4FA8-868D-29F242B485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C91AD4A-8E23-4F57-B192-B2DE47D66C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FE5BA-FAA6-4651-81EC-DEAC246416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7318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2721F1-78FB-4CFC-AA7F-016BE9F5AF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EF9A3DA-B56F-4274-A9BF-F10671FB0B8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9821D8E-68D2-4E39-9A92-5D045546A98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E3B6476-4853-4931-A52A-BEAE41F176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33761-7749-4B39-AA4E-F2614C788D62}" type="datetimeFigureOut">
              <a:rPr lang="en-US" smtClean="0"/>
              <a:t>8/10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A289E80-EBA5-49F3-A304-741903E270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00464A4-3E24-4183-95A7-96DC6C90CC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FE5BA-FAA6-4651-81EC-DEAC246416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48997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D82748-5324-4D1E-AD98-6477C32445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ADC8589-D3B3-4BB9-ACD6-7D8C14F4C9C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3B7DFBE-1A3E-48BB-A571-1BD69182026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AAD8596-E078-4ECD-A7D8-4E56762C6D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33761-7749-4B39-AA4E-F2614C788D62}" type="datetimeFigureOut">
              <a:rPr lang="en-US" smtClean="0"/>
              <a:t>8/10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5A8A0D0-DD86-4EFA-AFC8-4943D90DFD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9867AD3-03F0-4448-8103-D0F325A6EC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FE5BA-FAA6-4651-81EC-DEAC246416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26178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15DB6EC-5287-475D-85C0-79451C7B74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2F72CD8-0010-49A6-9E00-75713DBA53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3CFCA8-C94F-45D3-99B5-93611CF7879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C33761-7749-4B39-AA4E-F2614C788D62}" type="datetimeFigureOut">
              <a:rPr lang="en-US" smtClean="0"/>
              <a:t>8/1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3F1AAE-29F3-4A71-87A6-6CDB2F816E5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551A6A2-86D6-453F-B9C5-12231E99D02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0FE5BA-FAA6-4651-81EC-DEAC246416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80565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59">
            <a:extLst>
              <a:ext uri="{FF2B5EF4-FFF2-40B4-BE49-F238E27FC236}">
                <a16:creationId xmlns:a16="http://schemas.microsoft.com/office/drawing/2014/main" id="{7CE6E790-D0C3-41FB-AF0A-FB3C2F8BF0D5}"/>
              </a:ext>
            </a:extLst>
          </p:cNvPr>
          <p:cNvSpPr txBox="1"/>
          <p:nvPr/>
        </p:nvSpPr>
        <p:spPr>
          <a:xfrm>
            <a:off x="136356" y="178662"/>
            <a:ext cx="368969" cy="2463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1" b="1" dirty="0"/>
              <a:t>A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9D42E076-48DD-45A6-9A1F-D8E6F654D6F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0137" y="424883"/>
            <a:ext cx="1906574" cy="1224966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FD3C93D7-8543-4C3C-8898-9E9707C86636}"/>
              </a:ext>
            </a:extLst>
          </p:cNvPr>
          <p:cNvSpPr txBox="1"/>
          <p:nvPr/>
        </p:nvSpPr>
        <p:spPr>
          <a:xfrm>
            <a:off x="0" y="6352568"/>
            <a:ext cx="1155031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/>
              <a:t>Sub Figure 1. </a:t>
            </a:r>
            <a:r>
              <a:rPr lang="en-US" sz="1000" b="1" dirty="0">
                <a:solidFill>
                  <a:srgbClr val="0000CC"/>
                </a:solidFill>
              </a:rPr>
              <a:t>Ang II abdominal Aorta and Ang II thoracic aorta upregulated different extracellular matrix genes. </a:t>
            </a:r>
            <a:r>
              <a:rPr lang="en-US" sz="1000" dirty="0"/>
              <a:t>A. Extracellular matrix gene list from QIAGEN (Cat. no. 330231 PAMM-013ZR). Venn diagram of upregulated ECM genes in abdominal aorta and thoracic aorta of Ang II-induced AAA.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9CE2CAA-45F6-4FDC-982A-2660804558AB}"/>
              </a:ext>
            </a:extLst>
          </p:cNvPr>
          <p:cNvSpPr txBox="1"/>
          <p:nvPr/>
        </p:nvSpPr>
        <p:spPr>
          <a:xfrm>
            <a:off x="298957" y="1649849"/>
            <a:ext cx="705855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/>
              <a:t>Mmp14 Col2a1 Mmp13</a:t>
            </a:r>
            <a:endParaRPr lang="en-US" sz="10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59D09CE-2C24-440E-B48F-41ABB822CE95}"/>
              </a:ext>
            </a:extLst>
          </p:cNvPr>
          <p:cNvSpPr txBox="1"/>
          <p:nvPr/>
        </p:nvSpPr>
        <p:spPr>
          <a:xfrm>
            <a:off x="1155992" y="1633807"/>
            <a:ext cx="705855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/>
              <a:t>Selp Itgam Vcam1 Mmp12 Sele Col1a1 Itgax Spp1 Timp1 Thbs1</a:t>
            </a:r>
            <a:endParaRPr lang="en-US" sz="10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6BDB576-FA5A-4E5D-A03A-3B390A171B09}"/>
              </a:ext>
            </a:extLst>
          </p:cNvPr>
          <p:cNvSpPr txBox="1"/>
          <p:nvPr/>
        </p:nvSpPr>
        <p:spPr>
          <a:xfrm>
            <a:off x="1922354" y="1649849"/>
            <a:ext cx="5855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/>
              <a:t>Col3a1 Itgb2 Mmp8 Fn1</a:t>
            </a:r>
            <a:endParaRPr lang="en-US" sz="1000" dirty="0"/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B8CBB098-A4F2-4C0E-A2E1-539C57AD8995}"/>
              </a:ext>
            </a:extLst>
          </p:cNvPr>
          <p:cNvCxnSpPr/>
          <p:nvPr/>
        </p:nvCxnSpPr>
        <p:spPr>
          <a:xfrm>
            <a:off x="708031" y="1256818"/>
            <a:ext cx="0" cy="37698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000F54B3-4801-4872-B9CE-26573C39C44E}"/>
              </a:ext>
            </a:extLst>
          </p:cNvPr>
          <p:cNvCxnSpPr/>
          <p:nvPr/>
        </p:nvCxnSpPr>
        <p:spPr>
          <a:xfrm>
            <a:off x="1403424" y="1272860"/>
            <a:ext cx="0" cy="37698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477067F6-F8FD-41AF-BC4D-1B40B4B069B8}"/>
              </a:ext>
            </a:extLst>
          </p:cNvPr>
          <p:cNvCxnSpPr/>
          <p:nvPr/>
        </p:nvCxnSpPr>
        <p:spPr>
          <a:xfrm>
            <a:off x="2053129" y="1272860"/>
            <a:ext cx="0" cy="37698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F5F35A28-9526-4F73-9C7C-A1AF96D8AD14}"/>
              </a:ext>
            </a:extLst>
          </p:cNvPr>
          <p:cNvSpPr txBox="1"/>
          <p:nvPr/>
        </p:nvSpPr>
        <p:spPr>
          <a:xfrm>
            <a:off x="341259" y="178662"/>
            <a:ext cx="10621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Abdominal aort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2FD1C99-398B-43A6-9046-EA3D1369FAD6}"/>
              </a:ext>
            </a:extLst>
          </p:cNvPr>
          <p:cNvSpPr txBox="1"/>
          <p:nvPr/>
        </p:nvSpPr>
        <p:spPr>
          <a:xfrm>
            <a:off x="1457147" y="184650"/>
            <a:ext cx="9545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Thoracic aorta</a:t>
            </a:r>
          </a:p>
        </p:txBody>
      </p:sp>
    </p:spTree>
    <p:extLst>
      <p:ext uri="{BB962C8B-B14F-4D97-AF65-F5344CB8AC3E}">
        <p14:creationId xmlns:p14="http://schemas.microsoft.com/office/powerpoint/2010/main" val="29582482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</TotalTime>
  <Words>74</Words>
  <Application>Microsoft Office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ifan Lu</dc:creator>
  <cp:lastModifiedBy>Yifan Lu</cp:lastModifiedBy>
  <cp:revision>1</cp:revision>
  <dcterms:created xsi:type="dcterms:W3CDTF">2023-08-10T18:28:03Z</dcterms:created>
  <dcterms:modified xsi:type="dcterms:W3CDTF">2023-08-10T19:01:52Z</dcterms:modified>
</cp:coreProperties>
</file>